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7C9B3-0B9E-4987-82CD-56A8478C93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BE63B-C4B3-4017-99D0-66C9FA47D8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C43860-8C7C-4407-B2AB-29B819875F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1AEEF-E738-4D9E-8B3D-64082AF305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C6896-1279-4772-BFDA-C1F59ECF0A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5508AD-7AED-432B-B105-941A6867EA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E1334-DB50-4F3F-AAEB-759B8AC6B4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0AC6EA-D779-4D5F-90E5-32C37EC6E9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5D51F-2DA7-43DE-B24C-C0962DB090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E490C-BB1C-42AA-95EE-F88843A346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A270C0-655C-47F2-90BC-E355143529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8B8F8-4F7C-458F-822F-66AC4DBCA7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AA96462-99C0-4A88-884C-462ABFDBF506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75A7033-2C83-431C-BF20-B74D215E962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9"/>
          <p:cNvGrpSpPr/>
          <p:nvPr/>
        </p:nvGrpSpPr>
        <p:grpSpPr>
          <a:xfrm>
            <a:off x="1536480" y="1735560"/>
            <a:ext cx="4329360" cy="4303440"/>
            <a:chOff x="1536480" y="1735560"/>
            <a:chExt cx="4329360" cy="4303440"/>
          </a:xfrm>
        </p:grpSpPr>
        <p:grpSp>
          <p:nvGrpSpPr>
            <p:cNvPr id="42" name="Group 3"/>
            <p:cNvGrpSpPr/>
            <p:nvPr/>
          </p:nvGrpSpPr>
          <p:grpSpPr>
            <a:xfrm>
              <a:off x="1566720" y="1735560"/>
              <a:ext cx="3670200" cy="1657440"/>
              <a:chOff x="1566720" y="1735560"/>
              <a:chExt cx="3670200" cy="1657440"/>
            </a:xfrm>
          </p:grpSpPr>
          <p:sp>
            <p:nvSpPr>
              <p:cNvPr id="43" name="Rectangle 4"/>
              <p:cNvSpPr/>
              <p:nvPr/>
            </p:nvSpPr>
            <p:spPr>
              <a:xfrm>
                <a:off x="2959200" y="1844280"/>
                <a:ext cx="2277720" cy="91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+     -      -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MB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-     +     +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MBP-Os01g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+    +      -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GST-PGL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" name="Rectangle 11"/>
              <p:cNvSpPr/>
              <p:nvPr/>
            </p:nvSpPr>
            <p:spPr>
              <a:xfrm>
                <a:off x="1566720" y="3116520"/>
                <a:ext cx="708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anti-GS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Rectangle 12"/>
              <p:cNvSpPr/>
              <p:nvPr/>
            </p:nvSpPr>
            <p:spPr>
              <a:xfrm>
                <a:off x="4731840" y="2970000"/>
                <a:ext cx="184320" cy="369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Rectangle 18"/>
              <p:cNvSpPr/>
              <p:nvPr/>
            </p:nvSpPr>
            <p:spPr>
              <a:xfrm rot="10800000">
                <a:off x="2507760" y="1735560"/>
                <a:ext cx="362880" cy="106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vert="eaVer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GST-PGL1 inpu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7" name="Group 29"/>
            <p:cNvGrpSpPr/>
            <p:nvPr/>
          </p:nvGrpSpPr>
          <p:grpSpPr>
            <a:xfrm>
              <a:off x="1584360" y="4684320"/>
              <a:ext cx="4281480" cy="1354680"/>
              <a:chOff x="1584360" y="4684320"/>
              <a:chExt cx="4281480" cy="1354680"/>
            </a:xfrm>
          </p:grpSpPr>
          <p:pic>
            <p:nvPicPr>
              <p:cNvPr id="48" name="Picture 3" descr="pET12gvsGSTL02adjre079.jpg"/>
              <p:cNvPicPr/>
              <p:nvPr/>
            </p:nvPicPr>
            <p:blipFill>
              <a:blip r:embed="rId1"/>
              <a:srcRect l="17170" t="38763" r="47574" b="51592"/>
              <a:stretch/>
            </p:blipFill>
            <p:spPr>
              <a:xfrm>
                <a:off x="2494080" y="5731200"/>
                <a:ext cx="1769760" cy="307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9" name="TextBox 4"/>
              <p:cNvSpPr/>
              <p:nvPr/>
            </p:nvSpPr>
            <p:spPr>
              <a:xfrm>
                <a:off x="1584360" y="5744160"/>
                <a:ext cx="65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anti-His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Rectangle 4"/>
              <p:cNvSpPr/>
              <p:nvPr/>
            </p:nvSpPr>
            <p:spPr>
              <a:xfrm>
                <a:off x="2855160" y="4747680"/>
                <a:ext cx="301068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+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 -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   -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    GST-GF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-  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+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  +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    GST-PGL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+ 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+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   -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 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Trx-12g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Rectangle 18"/>
              <p:cNvSpPr/>
              <p:nvPr/>
            </p:nvSpPr>
            <p:spPr>
              <a:xfrm rot="10800000">
                <a:off x="2529360" y="4684320"/>
                <a:ext cx="362880" cy="983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Trx-12g inpu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2" name="Group 40"/>
            <p:cNvGrpSpPr/>
            <p:nvPr/>
          </p:nvGrpSpPr>
          <p:grpSpPr>
            <a:xfrm>
              <a:off x="1540800" y="3270960"/>
              <a:ext cx="4128480" cy="1280160"/>
              <a:chOff x="1540800" y="3270960"/>
              <a:chExt cx="4128480" cy="1280160"/>
            </a:xfrm>
          </p:grpSpPr>
          <p:pic>
            <p:nvPicPr>
              <p:cNvPr id="53" name="Picture 5" descr="G-04gvsM-L02result087.jpg"/>
              <p:cNvPicPr/>
              <p:nvPr/>
            </p:nvPicPr>
            <p:blipFill>
              <a:blip r:embed="rId2"/>
              <a:srcRect l="16762" t="51863" r="38486" b="42849"/>
              <a:stretch/>
            </p:blipFill>
            <p:spPr>
              <a:xfrm>
                <a:off x="2489040" y="4375440"/>
                <a:ext cx="1699200" cy="162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4" name="TextBox 6"/>
              <p:cNvSpPr/>
              <p:nvPr/>
            </p:nvSpPr>
            <p:spPr>
              <a:xfrm>
                <a:off x="1540800" y="4274640"/>
                <a:ext cx="854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anti-GS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Rectangle 4"/>
              <p:cNvSpPr/>
              <p:nvPr/>
            </p:nvSpPr>
            <p:spPr>
              <a:xfrm>
                <a:off x="2847240" y="3449160"/>
                <a:ext cx="282204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+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 -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-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MB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-  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+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+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MBP-PGL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+ 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+   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 -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GST-04g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	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Rectangle 18"/>
              <p:cNvSpPr/>
              <p:nvPr/>
            </p:nvSpPr>
            <p:spPr>
              <a:xfrm rot="10800000">
                <a:off x="2483280" y="3270960"/>
                <a:ext cx="362880" cy="1061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GST-04g inpu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7" name="TextBox 58"/>
            <p:cNvSpPr/>
            <p:nvPr/>
          </p:nvSpPr>
          <p:spPr>
            <a:xfrm>
              <a:off x="1578960" y="1898640"/>
              <a:ext cx="26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59"/>
            <p:cNvSpPr/>
            <p:nvPr/>
          </p:nvSpPr>
          <p:spPr>
            <a:xfrm>
              <a:off x="1543320" y="4002120"/>
              <a:ext cx="273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60"/>
            <p:cNvSpPr/>
            <p:nvPr/>
          </p:nvSpPr>
          <p:spPr>
            <a:xfrm>
              <a:off x="1536480" y="5012280"/>
              <a:ext cx="255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0" name="Picture 38" descr="1010512g1g pull resu007.jpg"/>
            <p:cNvPicPr/>
            <p:nvPr/>
          </p:nvPicPr>
          <p:blipFill>
            <a:blip r:embed="rId3"/>
            <a:srcRect l="8371" t="52604" r="49412" b="33937"/>
            <a:stretch/>
          </p:blipFill>
          <p:spPr>
            <a:xfrm>
              <a:off x="2481840" y="2954880"/>
              <a:ext cx="1706400" cy="4348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30T11:33:25Z</dcterms:created>
  <dc:creator>Dany Heang</dc:creator>
  <dc:description/>
  <dc:language>en-US</dc:language>
  <cp:lastModifiedBy>Dany Heang</cp:lastModifiedBy>
  <dcterms:modified xsi:type="dcterms:W3CDTF">2011-09-30T11:33:45Z</dcterms:modified>
  <cp:revision>1</cp:revision>
  <dc:subject/>
  <dc:title>Slide 1</dc:title>
</cp:coreProperties>
</file>